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fntdata" ContentType="application/x-fontdata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48" r:id="rId1"/>
  </p:sldMasterIdLst>
  <p:sldIdLst>
    <p:sldId id="260" r:id="rId2"/>
  </p:sldIdLst>
  <p:sldSz cx="12192000" cy="6858000"/>
  <p:notesSz cx="6858000" cy="9144000"/>
  <p:embeddedFontLst>
    <p:embeddedFont>
      <p:font typeface="Calibri" panose="020F0502020204030204" pitchFamily="34" charset="0"/>
      <p:regular r:id="rId3"/>
      <p:bold r:id="rId4"/>
      <p:italic r:id="rId5"/>
      <p:boldItalic r:id="rId6"/>
    </p:embeddedFont>
    <p:embeddedFont>
      <p:font typeface="Calibri Light" panose="020F0302020204030204" pitchFamily="34" charset="0"/>
      <p:regular r:id="rId7"/>
      <p:italic r:id="rId8"/>
    </p:embeddedFont>
  </p:embeddedFontLst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138" y="3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6.fntdata"/><Relationship Id="rId3" Type="http://schemas.openxmlformats.org/officeDocument/2006/relationships/font" Target="fonts/font1.fntdata"/><Relationship Id="rId7" Type="http://schemas.openxmlformats.org/officeDocument/2006/relationships/font" Target="fonts/font5.fntdata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4.fntdata"/><Relationship Id="rId11" Type="http://schemas.openxmlformats.org/officeDocument/2006/relationships/theme" Target="theme/theme1.xml"/><Relationship Id="rId5" Type="http://schemas.openxmlformats.org/officeDocument/2006/relationships/font" Target="fonts/font3.fntdata"/><Relationship Id="rId10" Type="http://schemas.openxmlformats.org/officeDocument/2006/relationships/viewProps" Target="viewProps.xml"/><Relationship Id="rId4" Type="http://schemas.openxmlformats.org/officeDocument/2006/relationships/font" Target="fonts/font2.fntdata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negative control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'CD4 graphs'!$B$7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CD4 graphs'!$C$1:$H$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cat>
          <c:val>
            <c:numRef>
              <c:f>'CD4 graphs'!$C$7:$H$7</c:f>
              <c:numCache>
                <c:formatCode>General</c:formatCode>
                <c:ptCount val="6"/>
                <c:pt idx="0">
                  <c:v>513684.26400000008</c:v>
                </c:pt>
                <c:pt idx="1">
                  <c:v>560026.46800000011</c:v>
                </c:pt>
                <c:pt idx="2">
                  <c:v>615276.4</c:v>
                </c:pt>
                <c:pt idx="3">
                  <c:v>613096.13099999994</c:v>
                </c:pt>
                <c:pt idx="4">
                  <c:v>654036.92345454544</c:v>
                </c:pt>
                <c:pt idx="5">
                  <c:v>684001.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D1C-4195-A925-B36018526F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43387368"/>
        <c:axId val="443386384"/>
      </c:lineChart>
      <c:scatterChart>
        <c:scatterStyle val="lineMarker"/>
        <c:varyColors val="0"/>
        <c:ser>
          <c:idx val="0"/>
          <c:order val="0"/>
          <c:tx>
            <c:strRef>
              <c:f>'CD4 graphs'!$B$2</c:f>
              <c:strCache>
                <c:ptCount val="1"/>
                <c:pt idx="0">
                  <c:v>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'CD4 graphs'!$C$1:$H$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4 graphs'!$C$2:$H$2</c:f>
              <c:numCache>
                <c:formatCode>General</c:formatCode>
                <c:ptCount val="6"/>
                <c:pt idx="0">
                  <c:v>506929.5</c:v>
                </c:pt>
                <c:pt idx="1">
                  <c:v>483847.65</c:v>
                </c:pt>
                <c:pt idx="2">
                  <c:v>634522</c:v>
                </c:pt>
                <c:pt idx="3">
                  <c:v>654843.73999999987</c:v>
                </c:pt>
                <c:pt idx="4">
                  <c:v>630712.60000000009</c:v>
                </c:pt>
                <c:pt idx="5">
                  <c:v>667585.799999999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D1C-4195-A925-B36018526F52}"/>
            </c:ext>
          </c:extLst>
        </c:ser>
        <c:ser>
          <c:idx val="1"/>
          <c:order val="1"/>
          <c:tx>
            <c:strRef>
              <c:f>'CD4 graphs'!$B$3</c:f>
              <c:strCache>
                <c:ptCount val="1"/>
                <c:pt idx="0">
                  <c:v>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'CD4 graphs'!$C$1:$H$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4 graphs'!$C$3:$H$3</c:f>
              <c:numCache>
                <c:formatCode>General</c:formatCode>
                <c:ptCount val="6"/>
                <c:pt idx="0">
                  <c:v>353834.23999999999</c:v>
                </c:pt>
                <c:pt idx="1">
                  <c:v>528719.4</c:v>
                </c:pt>
                <c:pt idx="2">
                  <c:v>544544</c:v>
                </c:pt>
                <c:pt idx="3">
                  <c:v>673689.24000000011</c:v>
                </c:pt>
                <c:pt idx="4">
                  <c:v>673443.75</c:v>
                </c:pt>
                <c:pt idx="5">
                  <c:v>75083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D1C-4195-A925-B36018526F52}"/>
            </c:ext>
          </c:extLst>
        </c:ser>
        <c:ser>
          <c:idx val="2"/>
          <c:order val="2"/>
          <c:tx>
            <c:strRef>
              <c:f>'CD4 graphs'!$B$4</c:f>
              <c:strCache>
                <c:ptCount val="1"/>
                <c:pt idx="0">
                  <c:v>3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'CD4 graphs'!$C$1:$H$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4 graphs'!$C$4:$H$4</c:f>
              <c:numCache>
                <c:formatCode>General</c:formatCode>
                <c:ptCount val="6"/>
                <c:pt idx="0">
                  <c:v>265816.32000000001</c:v>
                </c:pt>
                <c:pt idx="1">
                  <c:v>681817.29</c:v>
                </c:pt>
                <c:pt idx="2">
                  <c:v>769841.60000000009</c:v>
                </c:pt>
                <c:pt idx="3">
                  <c:v>532135.44999999995</c:v>
                </c:pt>
                <c:pt idx="4">
                  <c:v>649872.14</c:v>
                </c:pt>
                <c:pt idx="5">
                  <c:v>633585.7499999998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4D1C-4195-A925-B36018526F52}"/>
            </c:ext>
          </c:extLst>
        </c:ser>
        <c:ser>
          <c:idx val="3"/>
          <c:order val="3"/>
          <c:tx>
            <c:strRef>
              <c:f>'CD4 graphs'!$B$5</c:f>
              <c:strCache>
                <c:ptCount val="1"/>
                <c:pt idx="0">
                  <c:v>4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'CD4 graphs'!$C$1:$H$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4 graphs'!$C$5:$H$5</c:f>
              <c:numCache>
                <c:formatCode>General</c:formatCode>
                <c:ptCount val="6"/>
                <c:pt idx="0">
                  <c:v>812004.06</c:v>
                </c:pt>
                <c:pt idx="1">
                  <c:v>559378.4</c:v>
                </c:pt>
                <c:pt idx="2">
                  <c:v>451308</c:v>
                </c:pt>
                <c:pt idx="3">
                  <c:v>659559.82500000007</c:v>
                </c:pt>
                <c:pt idx="4">
                  <c:v>677008.8545454544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4D1C-4195-A925-B36018526F52}"/>
            </c:ext>
          </c:extLst>
        </c:ser>
        <c:ser>
          <c:idx val="4"/>
          <c:order val="4"/>
          <c:tx>
            <c:strRef>
              <c:f>'CD4 graphs'!$B$6</c:f>
              <c:strCache>
                <c:ptCount val="1"/>
                <c:pt idx="0">
                  <c:v>5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'CD4 graphs'!$C$1:$H$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4 graphs'!$C$6:$H$6</c:f>
              <c:numCache>
                <c:formatCode>General</c:formatCode>
                <c:ptCount val="6"/>
                <c:pt idx="0">
                  <c:v>629837.19999999995</c:v>
                </c:pt>
                <c:pt idx="1">
                  <c:v>546369.6</c:v>
                </c:pt>
                <c:pt idx="2">
                  <c:v>676166.39999999991</c:v>
                </c:pt>
                <c:pt idx="3">
                  <c:v>545252.4</c:v>
                </c:pt>
                <c:pt idx="4">
                  <c:v>639147.2727272727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4D1C-4195-A925-B36018526F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97456272"/>
        <c:axId val="497452008"/>
      </c:scatterChart>
      <c:catAx>
        <c:axId val="4433873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43386384"/>
        <c:crosses val="autoZero"/>
        <c:auto val="1"/>
        <c:lblAlgn val="ctr"/>
        <c:lblOffset val="100"/>
        <c:noMultiLvlLbl val="0"/>
      </c:catAx>
      <c:valAx>
        <c:axId val="443386384"/>
        <c:scaling>
          <c:orientation val="minMax"/>
          <c:max val="50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43387368"/>
        <c:crosses val="autoZero"/>
        <c:crossBetween val="between"/>
        <c:majorUnit val="1000000"/>
        <c:dispUnits>
          <c:builtInUnit val="hundredThousands"/>
          <c:dispUnitsLbl>
            <c:layout>
              <c:manualLayout>
                <c:xMode val="edge"/>
                <c:yMode val="edge"/>
                <c:x val="2.6780921708457941E-2"/>
                <c:y val="0.29473176550783914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>
                      <a:effectLst/>
                    </a:rPr>
                    <a:t>10</a:t>
                  </a:r>
                  <a:r>
                    <a:rPr lang="de-AT" sz="1000" baseline="30000">
                      <a:effectLst/>
                    </a:rPr>
                    <a:t>5 </a:t>
                  </a:r>
                  <a:r>
                    <a:rPr lang="de-AT" sz="1000" b="0" i="0" u="none" strike="noStrike" baseline="0">
                      <a:effectLst/>
                    </a:rPr>
                    <a:t>cells/m</a:t>
                  </a:r>
                  <a:r>
                    <a:rPr lang="de-AT" sz="1000">
                      <a:effectLst/>
                    </a:rPr>
                    <a:t>l</a:t>
                  </a: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497452008"/>
        <c:scaling>
          <c:orientation val="minMax"/>
          <c:max val="5000000"/>
        </c:scaling>
        <c:delete val="1"/>
        <c:axPos val="r"/>
        <c:numFmt formatCode="General" sourceLinked="1"/>
        <c:majorTickMark val="out"/>
        <c:minorTickMark val="none"/>
        <c:tickLblPos val="nextTo"/>
        <c:crossAx val="497456272"/>
        <c:crosses val="max"/>
        <c:crossBetween val="midCat"/>
      </c:valAx>
      <c:valAx>
        <c:axId val="497456272"/>
        <c:scaling>
          <c:orientation val="minMax"/>
        </c:scaling>
        <c:delete val="1"/>
        <c:axPos val="t"/>
        <c:majorTickMark val="out"/>
        <c:minorTickMark val="none"/>
        <c:tickLblPos val="nextTo"/>
        <c:crossAx val="497452008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vaccination-only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'CD4 graphs'!$B$16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CD4 graphs'!$C$10:$H$10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cat>
          <c:val>
            <c:numRef>
              <c:f>'CD4 graphs'!$C$16:$H$16</c:f>
              <c:numCache>
                <c:formatCode>General</c:formatCode>
                <c:ptCount val="6"/>
                <c:pt idx="0">
                  <c:v>612447.505</c:v>
                </c:pt>
                <c:pt idx="1">
                  <c:v>1158594.06</c:v>
                </c:pt>
                <c:pt idx="2">
                  <c:v>1694805.9</c:v>
                </c:pt>
                <c:pt idx="3">
                  <c:v>846771.32</c:v>
                </c:pt>
                <c:pt idx="4">
                  <c:v>731533.32400000002</c:v>
                </c:pt>
                <c:pt idx="5">
                  <c:v>868697.546666666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047-4520-BE72-A4C2CBE22B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41282168"/>
        <c:axId val="541281184"/>
      </c:lineChart>
      <c:scatterChart>
        <c:scatterStyle val="lineMarker"/>
        <c:varyColors val="0"/>
        <c:ser>
          <c:idx val="0"/>
          <c:order val="0"/>
          <c:tx>
            <c:strRef>
              <c:f>'CD4 graphs'!$B$11</c:f>
              <c:strCache>
                <c:ptCount val="1"/>
                <c:pt idx="0">
                  <c:v>6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'CD4 graphs'!$C$10:$H$10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4 graphs'!$C$11:$H$11</c:f>
              <c:numCache>
                <c:formatCode>General</c:formatCode>
                <c:ptCount val="6"/>
                <c:pt idx="0">
                  <c:v>786006.55</c:v>
                </c:pt>
                <c:pt idx="1">
                  <c:v>1692222</c:v>
                </c:pt>
                <c:pt idx="2">
                  <c:v>1468958.25</c:v>
                </c:pt>
                <c:pt idx="3">
                  <c:v>960845.39999999991</c:v>
                </c:pt>
                <c:pt idx="4">
                  <c:v>806846.4</c:v>
                </c:pt>
                <c:pt idx="5">
                  <c:v>11927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047-4520-BE72-A4C2CBE22B42}"/>
            </c:ext>
          </c:extLst>
        </c:ser>
        <c:ser>
          <c:idx val="1"/>
          <c:order val="1"/>
          <c:tx>
            <c:strRef>
              <c:f>'CD4 graphs'!$B$12</c:f>
              <c:strCache>
                <c:ptCount val="1"/>
                <c:pt idx="0">
                  <c:v>7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'CD4 graphs'!$C$10:$H$10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4 graphs'!$C$12:$H$12</c:f>
              <c:numCache>
                <c:formatCode>General</c:formatCode>
                <c:ptCount val="6"/>
                <c:pt idx="0">
                  <c:v>1100822.3600000001</c:v>
                </c:pt>
                <c:pt idx="1">
                  <c:v>1233035.7</c:v>
                </c:pt>
                <c:pt idx="2">
                  <c:v>1757193.75</c:v>
                </c:pt>
                <c:pt idx="3">
                  <c:v>666019.19999999995</c:v>
                </c:pt>
                <c:pt idx="4">
                  <c:v>999846.75</c:v>
                </c:pt>
                <c:pt idx="5">
                  <c:v>689474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B047-4520-BE72-A4C2CBE22B42}"/>
            </c:ext>
          </c:extLst>
        </c:ser>
        <c:ser>
          <c:idx val="2"/>
          <c:order val="2"/>
          <c:tx>
            <c:strRef>
              <c:f>'CD4 graphs'!$B$13</c:f>
              <c:strCache>
                <c:ptCount val="1"/>
                <c:pt idx="0">
                  <c:v>8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'CD4 graphs'!$C$10:$H$10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4 graphs'!$C$13:$H$13</c:f>
              <c:numCache>
                <c:formatCode>General</c:formatCode>
                <c:ptCount val="6"/>
                <c:pt idx="0">
                  <c:v>527152.34</c:v>
                </c:pt>
                <c:pt idx="1">
                  <c:v>1084915.8</c:v>
                </c:pt>
                <c:pt idx="2">
                  <c:v>1214513.9999999998</c:v>
                </c:pt>
                <c:pt idx="3">
                  <c:v>1041000.0000000001</c:v>
                </c:pt>
                <c:pt idx="4">
                  <c:v>515363.4200000001</c:v>
                </c:pt>
                <c:pt idx="5">
                  <c:v>723893.5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B047-4520-BE72-A4C2CBE22B42}"/>
            </c:ext>
          </c:extLst>
        </c:ser>
        <c:ser>
          <c:idx val="3"/>
          <c:order val="3"/>
          <c:tx>
            <c:strRef>
              <c:f>'CD4 graphs'!$B$14</c:f>
              <c:strCache>
                <c:ptCount val="1"/>
                <c:pt idx="0">
                  <c:v>9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'CD4 graphs'!$C$10:$H$10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4 graphs'!$C$14:$H$14</c:f>
              <c:numCache>
                <c:formatCode>General</c:formatCode>
                <c:ptCount val="6"/>
                <c:pt idx="0">
                  <c:v>434166.52500000002</c:v>
                </c:pt>
                <c:pt idx="1">
                  <c:v>530216.4</c:v>
                </c:pt>
                <c:pt idx="2">
                  <c:v>1950115.5</c:v>
                </c:pt>
                <c:pt idx="3">
                  <c:v>736288</c:v>
                </c:pt>
                <c:pt idx="4">
                  <c:v>687858.3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B047-4520-BE72-A4C2CBE22B42}"/>
            </c:ext>
          </c:extLst>
        </c:ser>
        <c:ser>
          <c:idx val="4"/>
          <c:order val="4"/>
          <c:tx>
            <c:strRef>
              <c:f>'CD4 graphs'!$B$15</c:f>
              <c:strCache>
                <c:ptCount val="1"/>
                <c:pt idx="0">
                  <c:v>1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'CD4 graphs'!$C$10:$H$10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4 graphs'!$C$15:$H$15</c:f>
              <c:numCache>
                <c:formatCode>General</c:formatCode>
                <c:ptCount val="6"/>
                <c:pt idx="0">
                  <c:v>214089.75</c:v>
                </c:pt>
                <c:pt idx="1">
                  <c:v>1252580.4000000001</c:v>
                </c:pt>
                <c:pt idx="2">
                  <c:v>2083248</c:v>
                </c:pt>
                <c:pt idx="3">
                  <c:v>829703.99999999988</c:v>
                </c:pt>
                <c:pt idx="4">
                  <c:v>647751.680000000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B047-4520-BE72-A4C2CBE22B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1905632"/>
        <c:axId val="521914816"/>
      </c:scatterChart>
      <c:catAx>
        <c:axId val="541282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41281184"/>
        <c:crosses val="autoZero"/>
        <c:auto val="1"/>
        <c:lblAlgn val="ctr"/>
        <c:lblOffset val="100"/>
        <c:noMultiLvlLbl val="0"/>
      </c:catAx>
      <c:valAx>
        <c:axId val="541281184"/>
        <c:scaling>
          <c:orientation val="minMax"/>
          <c:max val="50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41282168"/>
        <c:crosses val="autoZero"/>
        <c:crossBetween val="between"/>
        <c:majorUnit val="1000000"/>
        <c:dispUnits>
          <c:builtInUnit val="hundredThousands"/>
          <c:dispUnitsLbl>
            <c:layout>
              <c:manualLayout>
                <c:xMode val="edge"/>
                <c:yMode val="edge"/>
                <c:x val="2.4346292462234492E-2"/>
                <c:y val="0.29473176550783914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 b="0" i="0" baseline="0">
                      <a:effectLst/>
                    </a:rPr>
                    <a:t>10</a:t>
                  </a:r>
                  <a:r>
                    <a:rPr lang="de-AT" sz="1000" b="0" i="0" baseline="30000">
                      <a:effectLst/>
                    </a:rPr>
                    <a:t>5 </a:t>
                  </a:r>
                  <a:r>
                    <a:rPr lang="de-AT" sz="1000" b="0" i="0" baseline="0">
                      <a:effectLst/>
                    </a:rPr>
                    <a:t>cells/ml</a:t>
                  </a:r>
                  <a:endParaRPr lang="de-AT" sz="1000">
                    <a:effectLst/>
                  </a:endParaRP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521914816"/>
        <c:scaling>
          <c:orientation val="minMax"/>
          <c:max val="5000000"/>
        </c:scaling>
        <c:delete val="1"/>
        <c:axPos val="r"/>
        <c:numFmt formatCode="General" sourceLinked="1"/>
        <c:majorTickMark val="out"/>
        <c:minorTickMark val="none"/>
        <c:tickLblPos val="nextTo"/>
        <c:crossAx val="521905632"/>
        <c:crosses val="max"/>
        <c:crossBetween val="midCat"/>
      </c:valAx>
      <c:valAx>
        <c:axId val="521905632"/>
        <c:scaling>
          <c:orientation val="minMax"/>
        </c:scaling>
        <c:delete val="1"/>
        <c:axPos val="t"/>
        <c:majorTickMark val="out"/>
        <c:minorTickMark val="none"/>
        <c:tickLblPos val="nextTo"/>
        <c:crossAx val="521914816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challenge control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'CD4 graphs'!$B$25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CD4 graphs'!$C$19:$H$19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cat>
          <c:val>
            <c:numRef>
              <c:f>'CD4 graphs'!$C$25:$H$25</c:f>
              <c:numCache>
                <c:formatCode>General</c:formatCode>
                <c:ptCount val="6"/>
                <c:pt idx="0">
                  <c:v>591951.64519999991</c:v>
                </c:pt>
                <c:pt idx="1">
                  <c:v>694336.02</c:v>
                </c:pt>
                <c:pt idx="2">
                  <c:v>2532255.1859999998</c:v>
                </c:pt>
                <c:pt idx="3">
                  <c:v>3660551.5200000005</c:v>
                </c:pt>
                <c:pt idx="4">
                  <c:v>1963497.4100000001</c:v>
                </c:pt>
                <c:pt idx="5">
                  <c:v>1986553.3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8DB-4796-9C2B-F3CE3654E3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00049016"/>
        <c:axId val="500051312"/>
      </c:lineChart>
      <c:scatterChart>
        <c:scatterStyle val="lineMarker"/>
        <c:varyColors val="0"/>
        <c:ser>
          <c:idx val="0"/>
          <c:order val="0"/>
          <c:tx>
            <c:strRef>
              <c:f>'CD4 graphs'!$B$20</c:f>
              <c:strCache>
                <c:ptCount val="1"/>
                <c:pt idx="0">
                  <c:v>1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'CD4 graphs'!$C$19:$H$19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4 graphs'!$C$20:$H$20</c:f>
              <c:numCache>
                <c:formatCode>General</c:formatCode>
                <c:ptCount val="6"/>
                <c:pt idx="0">
                  <c:v>760972.80000000005</c:v>
                </c:pt>
                <c:pt idx="1">
                  <c:v>733837.5</c:v>
                </c:pt>
                <c:pt idx="2">
                  <c:v>2352066.7499999995</c:v>
                </c:pt>
                <c:pt idx="3">
                  <c:v>4195978.1999999993</c:v>
                </c:pt>
                <c:pt idx="4">
                  <c:v>2651200.15</c:v>
                </c:pt>
                <c:pt idx="5">
                  <c:v>253163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8DB-4796-9C2B-F3CE3654E3DE}"/>
            </c:ext>
          </c:extLst>
        </c:ser>
        <c:ser>
          <c:idx val="1"/>
          <c:order val="1"/>
          <c:tx>
            <c:strRef>
              <c:f>'CD4 graphs'!$B$21</c:f>
              <c:strCache>
                <c:ptCount val="1"/>
                <c:pt idx="0">
                  <c:v>1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'CD4 graphs'!$C$19:$H$19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4 graphs'!$C$21:$H$21</c:f>
              <c:numCache>
                <c:formatCode>General</c:formatCode>
                <c:ptCount val="6"/>
                <c:pt idx="0">
                  <c:v>447678.891</c:v>
                </c:pt>
                <c:pt idx="1">
                  <c:v>803635.19999999995</c:v>
                </c:pt>
                <c:pt idx="2">
                  <c:v>3795838.4</c:v>
                </c:pt>
                <c:pt idx="3">
                  <c:v>4628757</c:v>
                </c:pt>
                <c:pt idx="4">
                  <c:v>2456338.5</c:v>
                </c:pt>
                <c:pt idx="5">
                  <c:v>772925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8DB-4796-9C2B-F3CE3654E3DE}"/>
            </c:ext>
          </c:extLst>
        </c:ser>
        <c:ser>
          <c:idx val="2"/>
          <c:order val="2"/>
          <c:tx>
            <c:strRef>
              <c:f>'CD4 graphs'!$B$22</c:f>
              <c:strCache>
                <c:ptCount val="1"/>
                <c:pt idx="0">
                  <c:v>13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'CD4 graphs'!$C$19:$H$19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4 graphs'!$C$22:$H$22</c:f>
              <c:numCache>
                <c:formatCode>General</c:formatCode>
                <c:ptCount val="6"/>
                <c:pt idx="0">
                  <c:v>612556.21000000008</c:v>
                </c:pt>
                <c:pt idx="1">
                  <c:v>781042.5</c:v>
                </c:pt>
                <c:pt idx="2">
                  <c:v>2473532</c:v>
                </c:pt>
                <c:pt idx="3">
                  <c:v>3864759.6000000006</c:v>
                </c:pt>
                <c:pt idx="4">
                  <c:v>2223244.7999999998</c:v>
                </c:pt>
                <c:pt idx="5">
                  <c:v>2655100.7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D8DB-4796-9C2B-F3CE3654E3DE}"/>
            </c:ext>
          </c:extLst>
        </c:ser>
        <c:ser>
          <c:idx val="3"/>
          <c:order val="3"/>
          <c:tx>
            <c:strRef>
              <c:f>'CD4 graphs'!$B$23</c:f>
              <c:strCache>
                <c:ptCount val="1"/>
                <c:pt idx="0">
                  <c:v>14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'CD4 graphs'!$C$19:$H$19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4 graphs'!$C$23:$H$23</c:f>
              <c:numCache>
                <c:formatCode>General</c:formatCode>
                <c:ptCount val="6"/>
                <c:pt idx="0">
                  <c:v>719228.56499999994</c:v>
                </c:pt>
                <c:pt idx="1">
                  <c:v>414403.5</c:v>
                </c:pt>
                <c:pt idx="2">
                  <c:v>2494996.25</c:v>
                </c:pt>
                <c:pt idx="3">
                  <c:v>3554605.5</c:v>
                </c:pt>
                <c:pt idx="4">
                  <c:v>1098090.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D8DB-4796-9C2B-F3CE3654E3DE}"/>
            </c:ext>
          </c:extLst>
        </c:ser>
        <c:ser>
          <c:idx val="4"/>
          <c:order val="4"/>
          <c:tx>
            <c:strRef>
              <c:f>'CD4 graphs'!$B$24</c:f>
              <c:strCache>
                <c:ptCount val="1"/>
                <c:pt idx="0">
                  <c:v>15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'CD4 graphs'!$C$19:$H$19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4 graphs'!$C$24:$H$24</c:f>
              <c:numCache>
                <c:formatCode>General</c:formatCode>
                <c:ptCount val="6"/>
                <c:pt idx="0">
                  <c:v>419321.76</c:v>
                </c:pt>
                <c:pt idx="1">
                  <c:v>738761.4</c:v>
                </c:pt>
                <c:pt idx="2">
                  <c:v>1544842.53</c:v>
                </c:pt>
                <c:pt idx="3">
                  <c:v>2058657.3</c:v>
                </c:pt>
                <c:pt idx="4">
                  <c:v>1388613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D8DB-4796-9C2B-F3CE3654E3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40314008"/>
        <c:axId val="440315320"/>
      </c:scatterChart>
      <c:catAx>
        <c:axId val="5000490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00051312"/>
        <c:crosses val="autoZero"/>
        <c:auto val="1"/>
        <c:lblAlgn val="ctr"/>
        <c:lblOffset val="100"/>
        <c:noMultiLvlLbl val="0"/>
      </c:catAx>
      <c:valAx>
        <c:axId val="500051312"/>
        <c:scaling>
          <c:orientation val="minMax"/>
          <c:max val="50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00049016"/>
        <c:crosses val="autoZero"/>
        <c:crossBetween val="between"/>
        <c:majorUnit val="1000000"/>
        <c:dispUnits>
          <c:builtInUnit val="hundredThousands"/>
          <c:dispUnitsLbl>
            <c:layout>
              <c:manualLayout>
                <c:xMode val="edge"/>
                <c:yMode val="edge"/>
                <c:x val="2.6780921708457941E-2"/>
                <c:y val="0.29473176550783914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 b="0" i="0" baseline="0">
                      <a:effectLst/>
                    </a:rPr>
                    <a:t>10</a:t>
                  </a:r>
                  <a:r>
                    <a:rPr lang="de-AT" sz="1000" b="0" i="0" baseline="30000">
                      <a:effectLst/>
                    </a:rPr>
                    <a:t>5 </a:t>
                  </a:r>
                  <a:r>
                    <a:rPr lang="de-AT" sz="1000" b="0" i="0" baseline="0">
                      <a:effectLst/>
                    </a:rPr>
                    <a:t>cells/ml</a:t>
                  </a:r>
                  <a:endParaRPr lang="de-AT" sz="1000">
                    <a:effectLst/>
                  </a:endParaRP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440315320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440314008"/>
        <c:crosses val="max"/>
        <c:crossBetween val="midCat"/>
      </c:valAx>
      <c:valAx>
        <c:axId val="440314008"/>
        <c:scaling>
          <c:orientation val="minMax"/>
        </c:scaling>
        <c:delete val="1"/>
        <c:axPos val="t"/>
        <c:majorTickMark val="out"/>
        <c:minorTickMark val="none"/>
        <c:tickLblPos val="nextTo"/>
        <c:crossAx val="440315320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vaccinated/challenged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'CD4 graphs'!$B$34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CD4 graphs'!$C$28:$G$28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cat>
          <c:val>
            <c:numRef>
              <c:f>'CD4 graphs'!$C$34:$G$34</c:f>
              <c:numCache>
                <c:formatCode>General</c:formatCode>
                <c:ptCount val="5"/>
                <c:pt idx="0">
                  <c:v>1496043.5</c:v>
                </c:pt>
                <c:pt idx="1">
                  <c:v>2068996.4433333334</c:v>
                </c:pt>
                <c:pt idx="2">
                  <c:v>954952.78200000001</c:v>
                </c:pt>
                <c:pt idx="3">
                  <c:v>956402.04</c:v>
                </c:pt>
                <c:pt idx="4">
                  <c:v>773340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ECF-4E48-B56F-726FFCA9AB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54275024"/>
        <c:axId val="5477696"/>
      </c:lineChart>
      <c:scatterChart>
        <c:scatterStyle val="lineMarker"/>
        <c:varyColors val="0"/>
        <c:ser>
          <c:idx val="0"/>
          <c:order val="0"/>
          <c:tx>
            <c:strRef>
              <c:f>'CD4 graphs'!$B$29</c:f>
              <c:strCache>
                <c:ptCount val="1"/>
                <c:pt idx="0">
                  <c:v>16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'CD4 graphs'!$C$28:$G$28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'CD4 graphs'!$C$29:$G$29</c:f>
              <c:numCache>
                <c:formatCode>General</c:formatCode>
                <c:ptCount val="5"/>
                <c:pt idx="0">
                  <c:v>1023907.5</c:v>
                </c:pt>
                <c:pt idx="1">
                  <c:v>1966346.6666666665</c:v>
                </c:pt>
                <c:pt idx="2">
                  <c:v>1177272</c:v>
                </c:pt>
                <c:pt idx="3">
                  <c:v>596497.65</c:v>
                </c:pt>
                <c:pt idx="4">
                  <c:v>649740.000000000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ECF-4E48-B56F-726FFCA9AB88}"/>
            </c:ext>
          </c:extLst>
        </c:ser>
        <c:ser>
          <c:idx val="1"/>
          <c:order val="1"/>
          <c:tx>
            <c:strRef>
              <c:f>'CD4 graphs'!$B$30</c:f>
              <c:strCache>
                <c:ptCount val="1"/>
                <c:pt idx="0">
                  <c:v>17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'CD4 graphs'!$C$28:$G$28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'CD4 graphs'!$C$30:$G$30</c:f>
              <c:numCache>
                <c:formatCode>General</c:formatCode>
                <c:ptCount val="5"/>
                <c:pt idx="0">
                  <c:v>1598432.15</c:v>
                </c:pt>
                <c:pt idx="1">
                  <c:v>2483109.9</c:v>
                </c:pt>
                <c:pt idx="2">
                  <c:v>735676.8</c:v>
                </c:pt>
                <c:pt idx="3">
                  <c:v>921472.49999999988</c:v>
                </c:pt>
                <c:pt idx="4">
                  <c:v>896940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ECF-4E48-B56F-726FFCA9AB88}"/>
            </c:ext>
          </c:extLst>
        </c:ser>
        <c:ser>
          <c:idx val="2"/>
          <c:order val="2"/>
          <c:tx>
            <c:strRef>
              <c:f>'CD4 graphs'!$B$31</c:f>
              <c:strCache>
                <c:ptCount val="1"/>
                <c:pt idx="0">
                  <c:v>18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'CD4 graphs'!$C$28:$G$28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'CD4 graphs'!$C$31:$G$31</c:f>
              <c:numCache>
                <c:formatCode>General</c:formatCode>
                <c:ptCount val="5"/>
                <c:pt idx="0">
                  <c:v>2409467.2000000002</c:v>
                </c:pt>
                <c:pt idx="1">
                  <c:v>2845111.5</c:v>
                </c:pt>
                <c:pt idx="2">
                  <c:v>957646.4</c:v>
                </c:pt>
                <c:pt idx="3">
                  <c:v>89082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7ECF-4E48-B56F-726FFCA9AB88}"/>
            </c:ext>
          </c:extLst>
        </c:ser>
        <c:ser>
          <c:idx val="3"/>
          <c:order val="3"/>
          <c:tx>
            <c:strRef>
              <c:f>'CD4 graphs'!$B$32</c:f>
              <c:strCache>
                <c:ptCount val="1"/>
                <c:pt idx="0">
                  <c:v>19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'CD4 graphs'!$C$28:$G$28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'CD4 graphs'!$C$32:$G$32</c:f>
              <c:numCache>
                <c:formatCode>General</c:formatCode>
                <c:ptCount val="5"/>
                <c:pt idx="0">
                  <c:v>1435420.25</c:v>
                </c:pt>
                <c:pt idx="1">
                  <c:v>1752458.4</c:v>
                </c:pt>
                <c:pt idx="2">
                  <c:v>874690.4600000002</c:v>
                </c:pt>
                <c:pt idx="3">
                  <c:v>1002403.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7ECF-4E48-B56F-726FFCA9AB88}"/>
            </c:ext>
          </c:extLst>
        </c:ser>
        <c:ser>
          <c:idx val="4"/>
          <c:order val="4"/>
          <c:tx>
            <c:strRef>
              <c:f>'CD4 graphs'!$B$33</c:f>
              <c:strCache>
                <c:ptCount val="1"/>
                <c:pt idx="0">
                  <c:v>2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'CD4 graphs'!$C$28:$G$28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'CD4 graphs'!$C$33:$G$33</c:f>
              <c:numCache>
                <c:formatCode>General</c:formatCode>
                <c:ptCount val="5"/>
                <c:pt idx="0">
                  <c:v>1012990.4</c:v>
                </c:pt>
                <c:pt idx="1">
                  <c:v>1297955.75</c:v>
                </c:pt>
                <c:pt idx="2">
                  <c:v>1029478.25</c:v>
                </c:pt>
                <c:pt idx="3">
                  <c:v>1370816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7ECF-4E48-B56F-726FFCA9AB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3637808"/>
        <c:axId val="523643712"/>
      </c:scatterChart>
      <c:catAx>
        <c:axId val="454275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477696"/>
        <c:crosses val="autoZero"/>
        <c:auto val="1"/>
        <c:lblAlgn val="ctr"/>
        <c:lblOffset val="100"/>
        <c:noMultiLvlLbl val="0"/>
      </c:catAx>
      <c:valAx>
        <c:axId val="5477696"/>
        <c:scaling>
          <c:orientation val="minMax"/>
          <c:max val="50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54275024"/>
        <c:crosses val="autoZero"/>
        <c:crossBetween val="between"/>
        <c:majorUnit val="1000000"/>
        <c:dispUnits>
          <c:builtInUnit val="hundredThousands"/>
          <c:dispUnitsLbl>
            <c:layout>
              <c:manualLayout>
                <c:xMode val="edge"/>
                <c:yMode val="edge"/>
                <c:x val="2.4346292462234492E-2"/>
                <c:y val="0.30338888888888893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 b="0" i="0" baseline="0">
                      <a:effectLst/>
                    </a:rPr>
                    <a:t>10</a:t>
                  </a:r>
                  <a:r>
                    <a:rPr lang="de-AT" sz="1000" b="0" i="0" baseline="30000">
                      <a:effectLst/>
                    </a:rPr>
                    <a:t>5 </a:t>
                  </a:r>
                  <a:r>
                    <a:rPr lang="de-AT" sz="1000" b="0" i="0" baseline="0">
                      <a:effectLst/>
                    </a:rPr>
                    <a:t>cells/ml</a:t>
                  </a:r>
                  <a:endParaRPr lang="de-AT" sz="1000">
                    <a:effectLst/>
                  </a:endParaRP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523643712"/>
        <c:scaling>
          <c:orientation val="minMax"/>
          <c:max val="5000000"/>
        </c:scaling>
        <c:delete val="1"/>
        <c:axPos val="r"/>
        <c:numFmt formatCode="General" sourceLinked="1"/>
        <c:majorTickMark val="out"/>
        <c:minorTickMark val="none"/>
        <c:tickLblPos val="nextTo"/>
        <c:crossAx val="523637808"/>
        <c:crosses val="max"/>
        <c:crossBetween val="midCat"/>
      </c:valAx>
      <c:valAx>
        <c:axId val="523637808"/>
        <c:scaling>
          <c:orientation val="minMax"/>
        </c:scaling>
        <c:delete val="1"/>
        <c:axPos val="t"/>
        <c:majorTickMark val="out"/>
        <c:minorTickMark val="none"/>
        <c:tickLblPos val="nextTo"/>
        <c:crossAx val="523643712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46294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5253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7402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16784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190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37033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3198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7089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9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0548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4932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6703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337393" y="181408"/>
            <a:ext cx="11089341" cy="6313323"/>
            <a:chOff x="337393" y="181408"/>
            <a:chExt cx="11089341" cy="6313323"/>
          </a:xfrm>
        </p:grpSpPr>
        <p:grpSp>
          <p:nvGrpSpPr>
            <p:cNvPr id="5" name="Group 4"/>
            <p:cNvGrpSpPr/>
            <p:nvPr/>
          </p:nvGrpSpPr>
          <p:grpSpPr>
            <a:xfrm>
              <a:off x="337393" y="181408"/>
              <a:ext cx="11089341" cy="6313323"/>
              <a:chOff x="337393" y="181408"/>
              <a:chExt cx="11089341" cy="6313323"/>
            </a:xfrm>
          </p:grpSpPr>
          <p:grpSp>
            <p:nvGrpSpPr>
              <p:cNvPr id="4" name="Group 3"/>
              <p:cNvGrpSpPr/>
              <p:nvPr/>
            </p:nvGrpSpPr>
            <p:grpSpPr>
              <a:xfrm>
                <a:off x="337393" y="246291"/>
                <a:ext cx="11089341" cy="6248440"/>
                <a:chOff x="337393" y="246291"/>
                <a:chExt cx="11089341" cy="6248440"/>
              </a:xfrm>
            </p:grpSpPr>
            <p:graphicFrame>
              <p:nvGraphicFramePr>
                <p:cNvPr id="20" name="Chart 19"/>
                <p:cNvGraphicFramePr/>
                <p:nvPr>
                  <p:extLst>
                    <p:ext uri="{D42A27DB-BD31-4B8C-83A1-F6EECF244321}">
                      <p14:modId xmlns:p14="http://schemas.microsoft.com/office/powerpoint/2010/main" val="2755051802"/>
                    </p:ext>
                  </p:extLst>
                </p:nvPr>
              </p:nvGraphicFramePr>
              <p:xfrm>
                <a:off x="337393" y="246291"/>
                <a:ext cx="5216400" cy="2934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graphicFrame>
              <p:nvGraphicFramePr>
                <p:cNvPr id="28" name="Chart 27"/>
                <p:cNvGraphicFramePr/>
                <p:nvPr>
                  <p:extLst>
                    <p:ext uri="{D42A27DB-BD31-4B8C-83A1-F6EECF244321}">
                      <p14:modId xmlns:p14="http://schemas.microsoft.com/office/powerpoint/2010/main" val="3928882372"/>
                    </p:ext>
                  </p:extLst>
                </p:nvPr>
              </p:nvGraphicFramePr>
              <p:xfrm>
                <a:off x="6210334" y="246291"/>
                <a:ext cx="5216400" cy="2934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graphicFrame>
              <p:nvGraphicFramePr>
                <p:cNvPr id="30" name="Chart 29"/>
                <p:cNvGraphicFramePr/>
                <p:nvPr>
                  <p:extLst>
                    <p:ext uri="{D42A27DB-BD31-4B8C-83A1-F6EECF244321}">
                      <p14:modId xmlns:p14="http://schemas.microsoft.com/office/powerpoint/2010/main" val="3147267541"/>
                    </p:ext>
                  </p:extLst>
                </p:nvPr>
              </p:nvGraphicFramePr>
              <p:xfrm>
                <a:off x="337393" y="3560731"/>
                <a:ext cx="5216400" cy="2934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graphicFrame>
              <p:nvGraphicFramePr>
                <p:cNvPr id="34" name="Chart 33"/>
                <p:cNvGraphicFramePr/>
                <p:nvPr>
                  <p:extLst>
                    <p:ext uri="{D42A27DB-BD31-4B8C-83A1-F6EECF244321}">
                      <p14:modId xmlns:p14="http://schemas.microsoft.com/office/powerpoint/2010/main" val="2778272894"/>
                    </p:ext>
                  </p:extLst>
                </p:nvPr>
              </p:nvGraphicFramePr>
              <p:xfrm>
                <a:off x="6210334" y="3560731"/>
                <a:ext cx="5216400" cy="2934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</p:grpSp>
          <p:sp>
            <p:nvSpPr>
              <p:cNvPr id="8" name="TextBox 7"/>
              <p:cNvSpPr txBox="1"/>
              <p:nvPr/>
            </p:nvSpPr>
            <p:spPr>
              <a:xfrm>
                <a:off x="337393" y="181408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/>
                  <a:t>A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6185622" y="181408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 smtClean="0"/>
                  <a:t>B</a:t>
                </a:r>
                <a:endParaRPr lang="en-GB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337393" y="3560731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 smtClean="0"/>
                  <a:t>C</a:t>
                </a:r>
                <a:endParaRPr lang="en-GB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6185622" y="3560731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 smtClean="0"/>
                  <a:t>D</a:t>
                </a:r>
                <a:endParaRPr lang="en-GB" dirty="0"/>
              </a:p>
            </p:txBody>
          </p:sp>
        </p:grpSp>
        <p:sp>
          <p:nvSpPr>
            <p:cNvPr id="35" name="TextBox 34"/>
            <p:cNvSpPr txBox="1"/>
            <p:nvPr/>
          </p:nvSpPr>
          <p:spPr>
            <a:xfrm>
              <a:off x="9319152" y="1936831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691811" y="4223191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8567836" y="1546453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441791" y="3905349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4195553" y="4650640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7145176" y="4740885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8037441" y="4572748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8933025" y="5189946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9843306" y="5124042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7820917" y="1689876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499781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Office Theme</vt:lpstr>
      <vt:lpstr>PowerPoint Presentation</vt:lpstr>
    </vt:vector>
  </TitlesOfParts>
  <Company>Vetmeduni Vien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 Luca Carlotta</dc:creator>
  <cp:lastModifiedBy>De Luca Carlotta</cp:lastModifiedBy>
  <cp:revision>10</cp:revision>
  <dcterms:created xsi:type="dcterms:W3CDTF">2020-07-30T11:05:44Z</dcterms:created>
  <dcterms:modified xsi:type="dcterms:W3CDTF">2020-07-30T12:28:04Z</dcterms:modified>
</cp:coreProperties>
</file>